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8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wsedero" initials="h" lastIdx="2" clrIdx="0"/>
  <p:cmAuthor id="1" name="Soundarya Srirangan" initials="SS" lastIdx="9" clrIdx="1"/>
  <p:cmAuthor id="2" name="Jacob Thomas Dums" initials="JTD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43" autoAdjust="0"/>
    <p:restoredTop sz="99856" autoAdjust="0"/>
  </p:normalViewPr>
  <p:slideViewPr>
    <p:cSldViewPr>
      <p:cViewPr>
        <p:scale>
          <a:sx n="68" d="100"/>
          <a:sy n="68" d="100"/>
        </p:scale>
        <p:origin x="1636" y="-372"/>
      </p:cViewPr>
      <p:guideLst>
        <p:guide orient="horz" pos="3792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3" d="100"/>
          <a:sy n="53" d="100"/>
        </p:scale>
        <p:origin x="2624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0638EF7-21BA-46D6-B331-2665E60F3993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23745D-2A52-4D76-8184-F020C4DF11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3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3745D-2A52-4D76-8184-F020C4DF11F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6780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326241" y="5403755"/>
            <a:ext cx="60198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Figure. Separation of total lipids by thin layer chromatography - representative plate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otal lipids from 3 different samples were spotted (1.5 mg/lane) and separated with a petroleum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ther:diethy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ther:glacia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cetic acid (80:20:1) mobile phase. A standard mix was run along with the samples on each plate (48 </a:t>
            </a:r>
            <a:r>
              <a:rPr lang="el-GR" sz="1200" dirty="0" smtClean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 of each standard per lane). Iodine crystals were used to develop the plate. Three fractions: TAG, FFA, DAG (different fractions outlined in grey on the plate) were scraped off the plate and further processed for FAMES preparation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8" name="Group 37"/>
          <p:cNvGrpSpPr/>
          <p:nvPr/>
        </p:nvGrpSpPr>
        <p:grpSpPr>
          <a:xfrm>
            <a:off x="1219200" y="256401"/>
            <a:ext cx="4648200" cy="5077599"/>
            <a:chOff x="1219200" y="256401"/>
            <a:chExt cx="4648200" cy="5077599"/>
          </a:xfrm>
        </p:grpSpPr>
        <p:grpSp>
          <p:nvGrpSpPr>
            <p:cNvPr id="33" name="Group 32"/>
            <p:cNvGrpSpPr/>
            <p:nvPr/>
          </p:nvGrpSpPr>
          <p:grpSpPr>
            <a:xfrm>
              <a:off x="1219200" y="509752"/>
              <a:ext cx="4648200" cy="4824248"/>
              <a:chOff x="1219200" y="1295400"/>
              <a:chExt cx="4648200" cy="4824248"/>
            </a:xfrm>
          </p:grpSpPr>
          <p:pic>
            <p:nvPicPr>
              <p:cNvPr id="2" name="Picture 1" descr="C:\Users\Maria\Dropbox\Camera Uploads\2012-10-16 10.59.48.jpg"/>
              <p:cNvPicPr/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593" t="20223" r="20497" b="15375"/>
              <a:stretch/>
            </p:blipFill>
            <p:spPr bwMode="auto">
              <a:xfrm>
                <a:off x="1905000" y="1295400"/>
                <a:ext cx="2514600" cy="4824248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4419600" y="4564364"/>
                <a:ext cx="4953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DAG</a:t>
                </a:r>
                <a:endParaRPr lang="en-US" sz="8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4419600" y="4068170"/>
                <a:ext cx="1219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Linoleic acid</a:t>
                </a:r>
                <a:endParaRPr lang="en-US" sz="8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4419600" y="3048000"/>
                <a:ext cx="1219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Tocopherol</a:t>
                </a:r>
                <a:endParaRPr lang="en-US" sz="8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4419600" y="2590800"/>
                <a:ext cx="14478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Glyceryl</a:t>
                </a:r>
                <a:r>
                  <a:rPr lang="en-US" sz="8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n-US" sz="800" dirty="0" err="1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trioleate</a:t>
                </a:r>
                <a:endParaRPr lang="en-US" sz="8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cxnSp>
            <p:nvCxnSpPr>
              <p:cNvPr id="8" name="Straight Connector 7"/>
              <p:cNvCxnSpPr/>
              <p:nvPr/>
            </p:nvCxnSpPr>
            <p:spPr>
              <a:xfrm>
                <a:off x="4316817" y="4702863"/>
                <a:ext cx="182880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>
                <a:off x="4316817" y="4201633"/>
                <a:ext cx="182880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>
                <a:off x="4316817" y="3189767"/>
                <a:ext cx="182880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4316817" y="2732566"/>
                <a:ext cx="182880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Rectangle 11"/>
              <p:cNvSpPr/>
              <p:nvPr/>
            </p:nvSpPr>
            <p:spPr>
              <a:xfrm>
                <a:off x="3297866" y="2622699"/>
                <a:ext cx="594360" cy="1097280"/>
              </a:xfrm>
              <a:prstGeom prst="rect">
                <a:avLst/>
              </a:prstGeom>
              <a:noFill/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2645734" y="2636520"/>
                <a:ext cx="594360" cy="1097280"/>
              </a:xfrm>
              <a:prstGeom prst="rect">
                <a:avLst/>
              </a:prstGeom>
              <a:noFill/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1970567" y="2636520"/>
                <a:ext cx="594360" cy="1097280"/>
              </a:xfrm>
              <a:prstGeom prst="rect">
                <a:avLst/>
              </a:prstGeom>
              <a:noFill/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1949301" y="4052421"/>
                <a:ext cx="594360" cy="292608"/>
              </a:xfrm>
              <a:prstGeom prst="rect">
                <a:avLst/>
              </a:prstGeom>
              <a:noFill/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2682240" y="4058447"/>
                <a:ext cx="594360" cy="292608"/>
              </a:xfrm>
              <a:prstGeom prst="rect">
                <a:avLst/>
              </a:prstGeom>
              <a:noFill/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3342167" y="4058447"/>
                <a:ext cx="594360" cy="292608"/>
              </a:xfrm>
              <a:prstGeom prst="rect">
                <a:avLst/>
              </a:prstGeom>
              <a:noFill/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1941506" y="4450080"/>
                <a:ext cx="594360" cy="182880"/>
              </a:xfrm>
              <a:prstGeom prst="rect">
                <a:avLst/>
              </a:prstGeom>
              <a:noFill/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2671607" y="4444054"/>
                <a:ext cx="594360" cy="182880"/>
              </a:xfrm>
              <a:prstGeom prst="rect">
                <a:avLst/>
              </a:prstGeom>
              <a:noFill/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3336141" y="4465320"/>
                <a:ext cx="594360" cy="182880"/>
              </a:xfrm>
              <a:prstGeom prst="rect">
                <a:avLst/>
              </a:prstGeom>
              <a:noFill/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219200" y="3054632"/>
                <a:ext cx="5475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TAG</a:t>
                </a:r>
                <a:endParaRPr lang="en-US" sz="8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5" name="Left Brace 24"/>
              <p:cNvSpPr/>
              <p:nvPr/>
            </p:nvSpPr>
            <p:spPr>
              <a:xfrm>
                <a:off x="1752600" y="2643965"/>
                <a:ext cx="120502" cy="1084825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219200" y="4066401"/>
                <a:ext cx="5475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FFA</a:t>
                </a:r>
                <a:endParaRPr lang="en-US" sz="8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1219200" y="4419600"/>
                <a:ext cx="5475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DAG</a:t>
                </a:r>
                <a:endParaRPr lang="en-US" sz="8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0" name="Left Brace 29"/>
              <p:cNvSpPr/>
              <p:nvPr/>
            </p:nvSpPr>
            <p:spPr>
              <a:xfrm>
                <a:off x="1752600" y="4059866"/>
                <a:ext cx="120502" cy="274320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1" name="Left Brace 30"/>
              <p:cNvSpPr/>
              <p:nvPr/>
            </p:nvSpPr>
            <p:spPr>
              <a:xfrm>
                <a:off x="1752600" y="4450080"/>
                <a:ext cx="120502" cy="182880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1843502" y="260132"/>
              <a:ext cx="9154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Sample 1</a:t>
              </a:r>
              <a:endParaRPr lang="en-US" sz="8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514600" y="256401"/>
              <a:ext cx="9154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Sample 2</a:t>
              </a:r>
              <a:endParaRPr lang="en-US" sz="8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199336" y="256401"/>
              <a:ext cx="9154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Sample 3</a:t>
              </a:r>
              <a:endParaRPr lang="en-US" sz="8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496222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33</TotalTime>
  <Words>119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wsedero</dc:creator>
  <cp:lastModifiedBy>Soundarya Srirangan</cp:lastModifiedBy>
  <cp:revision>480</cp:revision>
  <cp:lastPrinted>2014-10-28T12:32:56Z</cp:lastPrinted>
  <dcterms:created xsi:type="dcterms:W3CDTF">2012-07-19T19:41:05Z</dcterms:created>
  <dcterms:modified xsi:type="dcterms:W3CDTF">2015-02-25T17:38:04Z</dcterms:modified>
</cp:coreProperties>
</file>